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906000" type="A4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2214" y="107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728700" y="632520"/>
            <a:ext cx="543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Arial" pitchFamily="34" charset="0"/>
                <a:cs typeface="Arial" pitchFamily="34" charset="0"/>
              </a:rPr>
              <a:t>Figure S3. Cumulative death rates for all-cause and cause-specific deaths among  three lipoprotein(a) [Lp(a)] groups.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28700" y="6537176"/>
            <a:ext cx="5436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The cumulative death rates of the low Lp(a) group are significantly higher than those of the intermediate Lp(a) group for all-cause, cancer, and miscellaneous-cause deaths. The cumulative death rate of the very high Lp(a) group is not higher than that of the intermediate Lp(a).</a:t>
            </a:r>
            <a:endParaRPr lang="ja-JP" altLang="ja-JP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図 5" descr="FigS4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4088" y="1568624"/>
            <a:ext cx="5445224" cy="451620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</TotalTime>
  <Words>71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otoji Sawabe</dc:creator>
  <cp:lastModifiedBy>Motoji Sawabe</cp:lastModifiedBy>
  <cp:revision>45</cp:revision>
  <dcterms:created xsi:type="dcterms:W3CDTF">2011-09-12T07:35:12Z</dcterms:created>
  <dcterms:modified xsi:type="dcterms:W3CDTF">2012-03-11T06:21:15Z</dcterms:modified>
</cp:coreProperties>
</file>